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70" r:id="rId3"/>
    <p:sldId id="269" r:id="rId4"/>
    <p:sldId id="268" r:id="rId5"/>
    <p:sldId id="267" r:id="rId6"/>
    <p:sldId id="266" r:id="rId7"/>
    <p:sldId id="265" r:id="rId8"/>
    <p:sldId id="264" r:id="rId9"/>
    <p:sldId id="263" r:id="rId10"/>
    <p:sldId id="262" r:id="rId11"/>
    <p:sldId id="261" r:id="rId12"/>
    <p:sldId id="260" r:id="rId13"/>
    <p:sldId id="259" r:id="rId14"/>
    <p:sldId id="257" r:id="rId15"/>
    <p:sldId id="258" r:id="rId16"/>
    <p:sldId id="271" r:id="rId17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10" d="100"/>
          <a:sy n="110" d="100"/>
        </p:scale>
        <p:origin x="164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tableStyles" Target="tableStyle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F3C4F2-1DD8-41DF-BCEE-101BE73CED6D}" type="datetimeFigureOut">
              <a:rPr lang="zh-CN" altLang="en-US" smtClean="0"/>
              <a:t>2021-1-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1CD4FC-C045-43F7-B4FA-4EAFB137A0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266783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F3C4F2-1DD8-41DF-BCEE-101BE73CED6D}" type="datetimeFigureOut">
              <a:rPr lang="zh-CN" altLang="en-US" smtClean="0"/>
              <a:t>2021-1-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1CD4FC-C045-43F7-B4FA-4EAFB137A0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702442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F3C4F2-1DD8-41DF-BCEE-101BE73CED6D}" type="datetimeFigureOut">
              <a:rPr lang="zh-CN" altLang="en-US" smtClean="0"/>
              <a:t>2021-1-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1CD4FC-C045-43F7-B4FA-4EAFB137A0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850568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F3C4F2-1DD8-41DF-BCEE-101BE73CED6D}" type="datetimeFigureOut">
              <a:rPr lang="zh-CN" altLang="en-US" smtClean="0"/>
              <a:t>2021-1-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1CD4FC-C045-43F7-B4FA-4EAFB137A0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233978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F3C4F2-1DD8-41DF-BCEE-101BE73CED6D}" type="datetimeFigureOut">
              <a:rPr lang="zh-CN" altLang="en-US" smtClean="0"/>
              <a:t>2021-1-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1CD4FC-C045-43F7-B4FA-4EAFB137A0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443796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F3C4F2-1DD8-41DF-BCEE-101BE73CED6D}" type="datetimeFigureOut">
              <a:rPr lang="zh-CN" altLang="en-US" smtClean="0"/>
              <a:t>2021-1-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1CD4FC-C045-43F7-B4FA-4EAFB137A0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12303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F3C4F2-1DD8-41DF-BCEE-101BE73CED6D}" type="datetimeFigureOut">
              <a:rPr lang="zh-CN" altLang="en-US" smtClean="0"/>
              <a:t>2021-1-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1CD4FC-C045-43F7-B4FA-4EAFB137A0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817759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F3C4F2-1DD8-41DF-BCEE-101BE73CED6D}" type="datetimeFigureOut">
              <a:rPr lang="zh-CN" altLang="en-US" smtClean="0"/>
              <a:t>2021-1-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1CD4FC-C045-43F7-B4FA-4EAFB137A0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134265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F3C4F2-1DD8-41DF-BCEE-101BE73CED6D}" type="datetimeFigureOut">
              <a:rPr lang="zh-CN" altLang="en-US" smtClean="0"/>
              <a:t>2021-1-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1CD4FC-C045-43F7-B4FA-4EAFB137A0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672962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F3C4F2-1DD8-41DF-BCEE-101BE73CED6D}" type="datetimeFigureOut">
              <a:rPr lang="zh-CN" altLang="en-US" smtClean="0"/>
              <a:t>2021-1-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1CD4FC-C045-43F7-B4FA-4EAFB137A0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988895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F3C4F2-1DD8-41DF-BCEE-101BE73CED6D}" type="datetimeFigureOut">
              <a:rPr lang="zh-CN" altLang="en-US" smtClean="0"/>
              <a:t>2021-1-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1CD4FC-C045-43F7-B4FA-4EAFB137A0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814262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F3C4F2-1DD8-41DF-BCEE-101BE73CED6D}" type="datetimeFigureOut">
              <a:rPr lang="zh-CN" altLang="en-US" smtClean="0"/>
              <a:t>2021-1-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1CD4FC-C045-43F7-B4FA-4EAFB137A0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488253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tiff"/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tiff"/><Relationship Id="rId1" Type="http://schemas.openxmlformats.org/officeDocument/2006/relationships/slideLayout" Target="../slideLayouts/slideLayout1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tiff"/><Relationship Id="rId1" Type="http://schemas.openxmlformats.org/officeDocument/2006/relationships/slideLayout" Target="../slideLayouts/slideLayout1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tiff"/><Relationship Id="rId1" Type="http://schemas.openxmlformats.org/officeDocument/2006/relationships/slideLayout" Target="../slideLayouts/slideLayout1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tiff"/><Relationship Id="rId1" Type="http://schemas.openxmlformats.org/officeDocument/2006/relationships/slideLayout" Target="../slideLayouts/slideLayout1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tiff"/><Relationship Id="rId1" Type="http://schemas.openxmlformats.org/officeDocument/2006/relationships/slideLayout" Target="../slideLayouts/slideLayout1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tif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tiff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17392" y="2626614"/>
            <a:ext cx="2109216" cy="16047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8182368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27348" y="2703576"/>
            <a:ext cx="1289304" cy="145084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4292149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16680" y="2798064"/>
            <a:ext cx="1310640" cy="12618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3380861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16680" y="2881884"/>
            <a:ext cx="1310640" cy="109423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3058967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41064" y="2881884"/>
            <a:ext cx="1261872" cy="109423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6093331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16680" y="2798064"/>
            <a:ext cx="1310640" cy="12618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9193780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41064" y="2881884"/>
            <a:ext cx="1261872" cy="109423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9298203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16680" y="2881884"/>
            <a:ext cx="1310640" cy="109423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3879759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17392" y="2626614"/>
            <a:ext cx="2109216" cy="16047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7672798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17392" y="2626614"/>
            <a:ext cx="2109216" cy="16047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6719069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17392" y="2626614"/>
            <a:ext cx="2109216" cy="16047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8389102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17392" y="2626614"/>
            <a:ext cx="2109216" cy="16047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0788371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46576" y="2784348"/>
            <a:ext cx="1450848" cy="128930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8842097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27348" y="2703576"/>
            <a:ext cx="1289304" cy="145084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6751725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27348" y="2703576"/>
            <a:ext cx="1289304" cy="145084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5007668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27348" y="2703576"/>
            <a:ext cx="1289304" cy="145084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6815185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</TotalTime>
  <Words>0</Words>
  <Application>Microsoft Office PowerPoint</Application>
  <PresentationFormat>全屏显示(4:3)</PresentationFormat>
  <Paragraphs>0</Paragraphs>
  <Slides>16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6</vt:i4>
      </vt:variant>
    </vt:vector>
  </HeadingPairs>
  <TitlesOfParts>
    <vt:vector size="21" baseType="lpstr">
      <vt:lpstr>宋体</vt:lpstr>
      <vt:lpstr>Arial</vt:lpstr>
      <vt:lpstr>Calibri</vt:lpstr>
      <vt:lpstr>Calibri Light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icrosoft 帐户</dc:creator>
  <cp:lastModifiedBy>Microsoft 帐户</cp:lastModifiedBy>
  <cp:revision>3</cp:revision>
  <dcterms:created xsi:type="dcterms:W3CDTF">2021-01-06T01:28:36Z</dcterms:created>
  <dcterms:modified xsi:type="dcterms:W3CDTF">2021-01-06T01:40:56Z</dcterms:modified>
</cp:coreProperties>
</file>